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34" y="9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38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431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253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344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769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962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395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139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206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007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706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5AF45-90EF-4EB8-85A7-8729DC43D762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0EBA65-4AA7-45D6-AD83-3FD029FEAD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488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6583" y="435429"/>
            <a:ext cx="8639084" cy="544135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372533" y="5876788"/>
            <a:ext cx="1181946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3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 for benzylate chloroquinolines against resistant strain K1. Compound 8d was removed from this analysis because of its non-detectable anti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ozo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.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0176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8:08Z</dcterms:created>
  <dcterms:modified xsi:type="dcterms:W3CDTF">2020-08-04T16:33:21Z</dcterms:modified>
</cp:coreProperties>
</file>